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65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C434B-D6A2-EBFF-1115-C84356D507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2C9FB6-7CA6-FDE5-C26D-88934E39EA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3F9588-1D7D-D877-2F27-1657004F2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A0B4DE-1B96-2FC8-49C8-A30A7A9AA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C9BCCD-6A8E-69F9-8ED7-1FEE9D31A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483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A7A8F3-2DE5-5CD9-37A6-A0229F2599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240057-E346-CA61-ABEB-30861924E3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398563-DAAF-D317-E380-8C6ADD0A2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C8B7CC-70A0-5130-CB45-C9CA7278B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43FAE-1FB4-30E5-9DC7-D1CE6EB350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740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843ED22-70BF-66C8-2CBE-1DF4738504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5F3ABD-5EE1-8619-DD36-C7A1028C61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238628-CE3C-7947-61DD-5C5C97758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CAE2DF-BDD4-5AB1-91D4-C66803245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3B3B7F-D52D-D5C1-53C9-B33DE9C65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113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A4D272-EC2F-BA85-BF24-9143E0690C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3E2F3A-57A9-A608-3376-8F9A9A7346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E9108F-957B-41DA-46D7-7A00DF468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ED3E03-F17F-B82E-7E34-D03A668DF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FCBAC6-CB60-3D02-0866-DE4EE737AB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538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273EB6-24F5-0984-85FA-A98C32183E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345878-49ED-B695-F894-A20B6F5446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DA1CC4-2540-083C-C83D-4F340399A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479C3F-343E-6D5C-C2A5-91E86BDEB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C2098F-F974-137D-51C5-9453208F2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31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5C7DFA-BC33-B16B-72B0-9A76CBE6EF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2889FE-037F-BA0C-9CC4-5CF03B8736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81F6EBD-2DD0-17DF-F969-FCBEF35B53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19FBFF-607C-1B5B-FF86-F88A15708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D8445C-27F2-AA03-F34C-E8CAA4465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5E5608-9935-C1EE-CF33-3562432CC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32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944A88-143B-29E4-93B1-9F3C3B383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D0C6BD-B5A8-8331-B253-E199A068B7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ED5E4D-C04E-A4AF-6C08-8028B2F8C5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6EF5D15-E1D6-C737-5331-0E136C5F91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5AF6C2-E1ED-188A-C6B9-B1DF9A0098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C578D3-2A67-45B8-EA73-70E10DF5DE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C990557-7C7D-7640-9F52-0AF5725AE3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D594BE5-6A17-0EB3-7BD0-9E9919238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027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6C386F-9328-CEA7-B6FD-3C04F391C7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6C8E19E-9CE1-16F5-A521-10E20CF44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D92741-F474-05A2-C3C9-94FA12B3C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EAD929-435E-CC60-F0AD-EEDE824C99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490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39830D-4A0D-621C-1450-FCBAA580E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5B59FDF-110F-FB7F-F0D0-98EE71953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B23B33-CECC-4055-04CF-511E954342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577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B700DB-F1A6-4B6A-7182-4324D7A3EE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EF7FCE-4081-9904-6CB6-D2BE493BFB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C455C6-2F72-1651-7B83-4EAEAAF628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50DFA5-69CC-5708-E0F7-0593945B8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01644C-84FA-E602-D10B-371E6F9F8D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EDDD10-A9C8-E495-3710-FF8CA35737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648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252FC3-6083-DCAA-B71E-BE97850B14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53368B0-A93B-2EDF-4B81-C77721E34C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364E9C-E6E4-B03C-0314-435ACD5626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58AEBF-AA84-39CA-67C6-B55DF6DAE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621B93-4249-57E8-2081-965FB8CDC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52FA40-00FF-1519-C38E-38EAB3EED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929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A09F31-4E3A-3F50-3FD9-2DE61280B6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C786A3-1307-96EE-6917-2A35ED4AC2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50783-F02B-62F7-B675-7D4D90A3DE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1FA48-B099-42D8-B954-7CC8C6C94DBF}" type="datetimeFigureOut">
              <a:rPr lang="en-US" smtClean="0"/>
              <a:t>12/3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BAECDA-532C-30CD-F2CC-E36F63A3FC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4A041B-44A3-8AF3-CA89-BFD6EA2BF2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2493EF-EEA1-48A6-8975-9A79DDF5E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011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6CC36D8-FF33-C8E3-2CD2-3B149FB53B5D}"/>
              </a:ext>
            </a:extLst>
          </p:cNvPr>
          <p:cNvGrpSpPr/>
          <p:nvPr/>
        </p:nvGrpSpPr>
        <p:grpSpPr>
          <a:xfrm>
            <a:off x="224530" y="3372762"/>
            <a:ext cx="11967470" cy="2473261"/>
            <a:chOff x="95742" y="431149"/>
            <a:chExt cx="11967470" cy="2473261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FE250FA8-51BC-B47F-CB58-77436950FAE6}"/>
                </a:ext>
              </a:extLst>
            </p:cNvPr>
            <p:cNvGrpSpPr/>
            <p:nvPr/>
          </p:nvGrpSpPr>
          <p:grpSpPr>
            <a:xfrm>
              <a:off x="95742" y="431149"/>
              <a:ext cx="11967470" cy="2473261"/>
              <a:chOff x="112265" y="509569"/>
              <a:chExt cx="11967470" cy="2473261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AEA60436-6DF4-4B86-0233-DF2DF071672A}"/>
                  </a:ext>
                </a:extLst>
              </p:cNvPr>
              <p:cNvGrpSpPr/>
              <p:nvPr/>
            </p:nvGrpSpPr>
            <p:grpSpPr>
              <a:xfrm>
                <a:off x="112265" y="509569"/>
                <a:ext cx="11967470" cy="2473261"/>
                <a:chOff x="-13385" y="1309669"/>
                <a:chExt cx="11967470" cy="2473261"/>
              </a:xfrm>
            </p:grpSpPr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D0A268AA-A6A3-18D2-BC00-A7636DD442D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-13385" y="1309669"/>
                  <a:ext cx="3170270" cy="2457428"/>
                </a:xfrm>
                <a:prstGeom prst="rect">
                  <a:avLst/>
                </a:prstGeom>
              </p:spPr>
            </p:pic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CDDD7C54-A0FE-6DD4-0357-D48EA6166E63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2964622" y="1323194"/>
                  <a:ext cx="3172968" cy="2459736"/>
                </a:xfrm>
                <a:prstGeom prst="rect">
                  <a:avLst/>
                </a:prstGeom>
              </p:spPr>
            </p:pic>
            <p:pic>
              <p:nvPicPr>
                <p:cNvPr id="14" name="Picture 13">
                  <a:extLst>
                    <a:ext uri="{FF2B5EF4-FFF2-40B4-BE49-F238E27FC236}">
                      <a16:creationId xmlns:a16="http://schemas.microsoft.com/office/drawing/2014/main" id="{95590D44-5135-B61C-C4E0-2377C8DCB98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8781117" y="1320886"/>
                  <a:ext cx="3172968" cy="2459736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C8162D37-A6C3-9F17-80F4-FF397523CCB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5862149" y="1323194"/>
                  <a:ext cx="3172968" cy="2459736"/>
                </a:xfrm>
                <a:prstGeom prst="rect">
                  <a:avLst/>
                </a:prstGeom>
              </p:spPr>
            </p:pic>
          </p:grp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DD97949F-425E-D911-2617-A153331BD9E8}"/>
                  </a:ext>
                </a:extLst>
              </p:cNvPr>
              <p:cNvSpPr/>
              <p:nvPr/>
            </p:nvSpPr>
            <p:spPr>
              <a:xfrm>
                <a:off x="568389" y="1622365"/>
                <a:ext cx="914400" cy="228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/8 survival</a:t>
                </a:r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DB49C6B8-13C5-1F09-0756-5B147C87BCE6}"/>
                  </a:ext>
                </a:extLst>
              </p:cNvPr>
              <p:cNvSpPr/>
              <p:nvPr/>
            </p:nvSpPr>
            <p:spPr>
              <a:xfrm>
                <a:off x="3660011" y="1634602"/>
                <a:ext cx="914400" cy="228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/8 survival</a:t>
                </a:r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545ABD21-8680-5BAB-688F-4CDD4B5D43D9}"/>
                  </a:ext>
                </a:extLst>
              </p:cNvPr>
              <p:cNvSpPr/>
              <p:nvPr/>
            </p:nvSpPr>
            <p:spPr>
              <a:xfrm>
                <a:off x="6557538" y="1651000"/>
                <a:ext cx="914400" cy="228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/8 survival</a:t>
                </a:r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2B165E30-22B2-BB95-612B-DF8CD643517C}"/>
                  </a:ext>
                </a:extLst>
              </p:cNvPr>
              <p:cNvSpPr/>
              <p:nvPr/>
            </p:nvSpPr>
            <p:spPr>
              <a:xfrm>
                <a:off x="9455065" y="1651000"/>
                <a:ext cx="914400" cy="228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/8 survival</a:t>
                </a:r>
              </a:p>
            </p:txBody>
          </p:sp>
        </p:grp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197E1DC9-9574-D4CD-1422-6B302452B0D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51866" y="2018923"/>
              <a:ext cx="11045623" cy="27160"/>
            </a:xfrm>
            <a:prstGeom prst="line">
              <a:avLst/>
            </a:prstGeom>
            <a:ln>
              <a:solidFill>
                <a:srgbClr val="FF0000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DA998387-FA87-DF63-BE62-C1563E943A24}"/>
              </a:ext>
            </a:extLst>
          </p:cNvPr>
          <p:cNvSpPr txBox="1"/>
          <p:nvPr/>
        </p:nvSpPr>
        <p:spPr>
          <a:xfrm>
            <a:off x="325925" y="217283"/>
            <a:ext cx="11036174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I-2. individual PDX growth curves. 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When PDXs reached the size of around 200 mm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3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, they were randomized to vehicle control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alpelisib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alone (50 mg/kg)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ceritinib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alone (50 mg/kg) and combination of these two drugs (25 mg/kg of each drug), eight mice per group. All medications were given through oral gavage once daily. Because most mice reached the humane endpoint of a tumor size of over 1,000 mm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3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, the experiment was terminated at Day 14. After reaching the size of around 3 times the baseline, some tumors developed ulceration which made the measurement of tumor size not accurate. Hence, we used the time fo</a:t>
            </a:r>
            <a:r>
              <a:rPr lang="en-US" dirty="0">
                <a:latin typeface="Times New Roman" panose="02020603050405020304" pitchFamily="18" charset="0"/>
                <a:ea typeface="DengXian" panose="02010600030101010101" pitchFamily="2" charset="-122"/>
              </a:rPr>
              <a:t>r 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tumor size to reach 3 times the baseline to calculate the accurate survival time. At day 14, except one mouse in the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alpelisib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group still had tumor less than 3 times the baseline, all other mice in the control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alpelisib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and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ceritinib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groups had tumors larger than the size lime.  In contrast, only 2 out of 8 mice in the combination group had tumor larger than 3 times </a:t>
            </a:r>
            <a:r>
              <a:rPr lang="en-US" sz="180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the baseline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63753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11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Chong-Xian</dc:creator>
  <cp:lastModifiedBy>Pan, Chong-Xian</cp:lastModifiedBy>
  <cp:revision>2</cp:revision>
  <dcterms:created xsi:type="dcterms:W3CDTF">2024-12-30T20:49:48Z</dcterms:created>
  <dcterms:modified xsi:type="dcterms:W3CDTF">2024-12-30T20:59:17Z</dcterms:modified>
</cp:coreProperties>
</file>